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00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852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883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1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12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28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1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8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16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2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91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406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F61FF6A-C129-43D7-9EB1-E93E8B4FBE52}"/>
              </a:ext>
            </a:extLst>
          </p:cNvPr>
          <p:cNvSpPr txBox="1"/>
          <p:nvPr/>
        </p:nvSpPr>
        <p:spPr>
          <a:xfrm>
            <a:off x="797889" y="398099"/>
            <a:ext cx="3180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CB2880B-DE2F-492E-AB15-7915B349F9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889" y="793067"/>
            <a:ext cx="7416568" cy="27308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DF163FE-AB6E-417A-AFA3-4AFE3DFA58C5}"/>
              </a:ext>
            </a:extLst>
          </p:cNvPr>
          <p:cNvSpPr txBox="1"/>
          <p:nvPr/>
        </p:nvSpPr>
        <p:spPr>
          <a:xfrm>
            <a:off x="722435" y="3739551"/>
            <a:ext cx="7699129" cy="215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Complete Response Achieved After Six Treatment Cycles.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significant reduction of SUV uptake at Cycle 2 is an early predictor of response as this patient achieves a CR at the Cycle 6. Non-target lesions in the lungs (indicated by arrows) show progressive decrease with a CR by Cycle 6. SD was assessed using the 2007 Revised Response Criteria for Malignant Lymphoma (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son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2007). PR or PMR by EORTC and Lugano 2014 criteria, respectively. Interpretation of FDG-PET imaging data followed the 5-point Deauville criteria (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ignan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2009). CR=complete response; EORTC=European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ganisation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Research and Treatment of Cancer; FDG-PET= fluorodeoxyglucose-positron emission tomography; MAX=maximum; PMR=partial metabolic response; PR=partial response; SD=stable disease; SUV=standardized uptake valu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9310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152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dy Nichols</dc:creator>
  <cp:lastModifiedBy>Cody Nichols</cp:lastModifiedBy>
  <cp:revision>7</cp:revision>
  <dcterms:created xsi:type="dcterms:W3CDTF">2022-01-07T19:09:15Z</dcterms:created>
  <dcterms:modified xsi:type="dcterms:W3CDTF">2022-05-16T15:14:04Z</dcterms:modified>
</cp:coreProperties>
</file>